
<file path=[Content_Types].xml><?xml version="1.0" encoding="utf-8"?>
<Types xmlns="http://schemas.openxmlformats.org/package/2006/content-types">
  <Default Extension="png" ContentType="image/png"/>
  <Default Extension="mov" ContentType="video/quicktime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8" r:id="rId2"/>
  </p:sldIdLst>
  <p:sldSz cx="9144000" cy="6858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18" userDrawn="1">
          <p15:clr>
            <a:srgbClr val="A4A3A4"/>
          </p15:clr>
        </p15:guide>
        <p15:guide id="2" pos="85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944" y="52"/>
      </p:cViewPr>
      <p:guideLst>
        <p:guide orient="horz" pos="618"/>
        <p:guide pos="85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1EB0E0-D011-482A-A670-CEA245F17EBB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82469A9-490C-4A3A-8DF5-D941F785815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612043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4B16F-C60F-4D6D-A13A-9A4ADB31CD33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53FB-9C1D-47C0-B416-B34137D5F76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831012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4B16F-C60F-4D6D-A13A-9A4ADB31CD33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53FB-9C1D-47C0-B416-B34137D5F76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443308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4B16F-C60F-4D6D-A13A-9A4ADB31CD33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53FB-9C1D-47C0-B416-B34137D5F76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52273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4B16F-C60F-4D6D-A13A-9A4ADB31CD33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53FB-9C1D-47C0-B416-B34137D5F76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0928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4B16F-C60F-4D6D-A13A-9A4ADB31CD33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53FB-9C1D-47C0-B416-B34137D5F76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302042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4B16F-C60F-4D6D-A13A-9A4ADB31CD33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53FB-9C1D-47C0-B416-B34137D5F76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308488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4B16F-C60F-4D6D-A13A-9A4ADB31CD33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53FB-9C1D-47C0-B416-B34137D5F76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3036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4B16F-C60F-4D6D-A13A-9A4ADB31CD33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53FB-9C1D-47C0-B416-B34137D5F76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47604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4B16F-C60F-4D6D-A13A-9A4ADB31CD33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53FB-9C1D-47C0-B416-B34137D5F76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799373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4B16F-C60F-4D6D-A13A-9A4ADB31CD33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53FB-9C1D-47C0-B416-B34137D5F76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19739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4B16F-C60F-4D6D-A13A-9A4ADB31CD33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53FB-9C1D-47C0-B416-B34137D5F76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099854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84B16F-C60F-4D6D-A13A-9A4ADB31CD33}" type="datetimeFigureOut">
              <a:rPr lang="zh-TW" altLang="en-US" smtClean="0"/>
              <a:t>2022/4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CC53FB-9C1D-47C0-B416-B34137D5F76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26778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ov"/><Relationship Id="rId1" Type="http://schemas.microsoft.com/office/2007/relationships/media" Target="../media/media1.mov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zebra_N(4)200nm_006 movie (Converted)">
            <a:hlinkClick r:id="" action="ppaction://media"/>
            <a:extLst>
              <a:ext uri="{FF2B5EF4-FFF2-40B4-BE49-F238E27FC236}">
                <a16:creationId xmlns:a16="http://schemas.microsoft.com/office/drawing/2014/main" id="{0D449188-D394-4A98-BFA3-E25BD5D4ECB0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754526" y="296978"/>
            <a:ext cx="5487166" cy="3086531"/>
          </a:xfrm>
          <a:prstGeom prst="rect">
            <a:avLst/>
          </a:prstGeom>
        </p:spPr>
      </p:pic>
      <p:sp>
        <p:nvSpPr>
          <p:cNvPr id="2" name="矩形 1"/>
          <p:cNvSpPr/>
          <p:nvPr/>
        </p:nvSpPr>
        <p:spPr>
          <a:xfrm>
            <a:off x="424873" y="3638195"/>
            <a:ext cx="8442036" cy="2677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-1270" algn="just">
              <a:lnSpc>
                <a:spcPct val="150000"/>
              </a:lnSpc>
              <a:spcAft>
                <a:spcPts val="1000"/>
              </a:spcAft>
            </a:pPr>
            <a:r>
              <a:rPr lang="en-US" altLang="zh-TW" sz="1600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DEO S3</a:t>
            </a:r>
            <a:r>
              <a:rPr lang="en-US" altLang="zh-TW" sz="1600" b="1" dirty="0"/>
              <a:t> │</a:t>
            </a:r>
            <a:r>
              <a:rPr lang="en-US" altLang="zh-TW" sz="16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US" altLang="zh-TW" sz="1600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4-RMSN</a:t>
            </a:r>
            <a:r>
              <a:rPr lang="en-US" altLang="zh-TW" sz="1600" b="1" kern="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r>
              <a:rPr lang="en-US" altLang="zh-TW" sz="1600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@PEG/THPMP injected into </a:t>
            </a:r>
            <a:r>
              <a:rPr lang="en-US" altLang="zh-TW" sz="1600" b="1" i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g</a:t>
            </a:r>
            <a:r>
              <a:rPr lang="en-US" altLang="zh-TW" sz="1600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TW" sz="1600" b="1" i="1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zfli</a:t>
            </a:r>
            <a:r>
              <a:rPr lang="en-US" altLang="zh-TW" sz="1600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EGFP) transgenic zebrafish. </a:t>
            </a:r>
            <a:r>
              <a:rPr lang="en-US" altLang="zh-TW" sz="16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fter a pericardial cavity injection of N4-RMSN</a:t>
            </a:r>
            <a:r>
              <a:rPr lang="en-US" altLang="zh-TW" sz="1600" kern="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r>
              <a:rPr lang="en-US" altLang="zh-TW" sz="16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@PEG/THPMP (100~200 ng/embryo) and photographing at 4 days post-fertilization (</a:t>
            </a:r>
            <a:r>
              <a:rPr lang="en-US" altLang="zh-TW" sz="1600" kern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pf</a:t>
            </a:r>
            <a:r>
              <a:rPr lang="en-US" altLang="zh-TW" sz="16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the movie clip file shows results of the N4-RMSN</a:t>
            </a:r>
            <a:r>
              <a:rPr lang="en-US" altLang="zh-TW" sz="1600" kern="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r>
              <a:rPr lang="en-US" altLang="zh-TW" sz="16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@PEG/THPMP injection. The red fluorescence (RITC) indicates nanoparticles, and the green fluorescence (GFP, green) indicates blood vessels in the brain.</a:t>
            </a:r>
            <a:r>
              <a:rPr lang="en-US" altLang="zh-TW" sz="1600" kern="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6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ata showed that N4-RMSN</a:t>
            </a:r>
            <a:r>
              <a:rPr lang="en-US" altLang="zh-TW" sz="1600" kern="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r>
              <a:rPr lang="en-US" altLang="zh-TW" sz="16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@PEG/THPMP-injected zebrafish had lower red fluorescence (RITC) of nanoparticles outside the brain's blood vessels than did N4-RMSN</a:t>
            </a:r>
            <a:r>
              <a:rPr lang="en-US" altLang="zh-TW" sz="1600" kern="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altLang="zh-TW" sz="1600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@PEG/THPMP injected zebrafish.</a:t>
            </a:r>
            <a:endParaRPr lang="zh-TW" altLang="zh-TW" sz="1600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9541979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7</TotalTime>
  <Words>118</Words>
  <Application>Microsoft Office PowerPoint</Application>
  <PresentationFormat>如螢幕大小 (4:3)</PresentationFormat>
  <Paragraphs>1</Paragraphs>
  <Slides>1</Slides>
  <Notes>0</Notes>
  <HiddenSlides>0</HiddenSlides>
  <MMClips>1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7" baseType="lpstr">
      <vt:lpstr>新細明體</vt:lpstr>
      <vt:lpstr>Arial</vt:lpstr>
      <vt:lpstr>Calibri</vt:lpstr>
      <vt:lpstr>Calibri Light</vt:lpstr>
      <vt:lpstr>Times New Roman</vt:lpstr>
      <vt:lpstr>Office 佈景主題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祖原 張</dc:creator>
  <cp:lastModifiedBy>HayChen</cp:lastModifiedBy>
  <cp:revision>42</cp:revision>
  <dcterms:created xsi:type="dcterms:W3CDTF">2020-02-25T09:53:37Z</dcterms:created>
  <dcterms:modified xsi:type="dcterms:W3CDTF">2022-04-28T18:06:03Z</dcterms:modified>
</cp:coreProperties>
</file>